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5638" cy="92916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D07185-BC95-476A-85DE-581893CF54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ACFEAF-E5E5-4C68-B2F1-3341B413B7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8A8825-6FE8-4061-BA32-5DF2C502DC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969F3A-4D9A-4564-B9A1-C0939D4AB2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455995-9DC5-404A-BEFB-B6E6272C4E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376D77-5600-47B2-BA5D-5CEF9792A3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EA3FC6-A5E6-40DB-BF0B-AFA076E493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F3B483-AAFD-45C1-B025-579C75E49D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40E6CC-E050-4B78-9F53-4C3CD58E1F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24BFE6-A838-4DBF-9B27-EC3B6E4C65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4DC42C-4965-4032-A1B4-E075F12134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4FE637-F44E-4395-A433-9555842F5E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8C1D0F-A77E-4D35-BF21-30E5F24764FC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93560" y="735120"/>
            <a:ext cx="4344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Fig. S8   Glutathione oxidases (A), superoxide dismutases (B) and peroxiredoxins (C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876240" y="1763640"/>
            <a:ext cx="4978440" cy="5490720"/>
            <a:chOff x="876240" y="1763640"/>
            <a:chExt cx="4978440" cy="5490720"/>
          </a:xfrm>
        </p:grpSpPr>
        <p:sp>
          <p:nvSpPr>
            <p:cNvPr id="43" name=""/>
            <p:cNvSpPr/>
            <p:nvPr/>
          </p:nvSpPr>
          <p:spPr>
            <a:xfrm>
              <a:off x="876240" y="1765440"/>
              <a:ext cx="114480" cy="13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324240" y="1765440"/>
              <a:ext cx="114120" cy="13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B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735200" y="4462560"/>
              <a:ext cx="114120" cy="13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6" name=""/>
            <p:cNvGrpSpPr/>
            <p:nvPr/>
          </p:nvGrpSpPr>
          <p:grpSpPr>
            <a:xfrm>
              <a:off x="988920" y="1989000"/>
              <a:ext cx="1951200" cy="1963800"/>
              <a:chOff x="988920" y="1989000"/>
              <a:chExt cx="1951200" cy="1963800"/>
            </a:xfrm>
          </p:grpSpPr>
          <p:sp>
            <p:nvSpPr>
              <p:cNvPr id="47" name=""/>
              <p:cNvSpPr/>
              <p:nvPr/>
            </p:nvSpPr>
            <p:spPr>
              <a:xfrm rot="12961800">
                <a:off x="2170080" y="3096360"/>
                <a:ext cx="42840" cy="4752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 rot="14754600">
                <a:off x="2079360" y="2975040"/>
                <a:ext cx="42840" cy="4788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1394280" y="1989000"/>
                <a:ext cx="975960" cy="774000"/>
              </a:xfrm>
              <a:custGeom>
                <a:avLst/>
                <a:gdLst/>
                <a:ahLst/>
                <a:rect l="l" t="t" r="r" b="b"/>
                <a:pathLst>
                  <a:path w="756" h="614">
                    <a:moveTo>
                      <a:pt x="511" y="603"/>
                    </a:moveTo>
                    <a:cubicBezTo>
                      <a:pt x="524" y="612"/>
                      <a:pt x="504" y="614"/>
                      <a:pt x="511" y="599"/>
                    </a:cubicBezTo>
                    <a:cubicBezTo>
                      <a:pt x="518" y="584"/>
                      <a:pt x="538" y="551"/>
                      <a:pt x="556" y="510"/>
                    </a:cubicBezTo>
                    <a:cubicBezTo>
                      <a:pt x="574" y="469"/>
                      <a:pt x="588" y="400"/>
                      <a:pt x="619" y="350"/>
                    </a:cubicBezTo>
                    <a:cubicBezTo>
                      <a:pt x="650" y="300"/>
                      <a:pt x="756" y="261"/>
                      <a:pt x="744" y="207"/>
                    </a:cubicBezTo>
                    <a:cubicBezTo>
                      <a:pt x="732" y="153"/>
                      <a:pt x="657" y="54"/>
                      <a:pt x="547" y="27"/>
                    </a:cubicBezTo>
                    <a:cubicBezTo>
                      <a:pt x="437" y="0"/>
                      <a:pt x="167" y="16"/>
                      <a:pt x="85" y="44"/>
                    </a:cubicBezTo>
                    <a:cubicBezTo>
                      <a:pt x="3" y="72"/>
                      <a:pt x="0" y="112"/>
                      <a:pt x="57" y="195"/>
                    </a:cubicBezTo>
                    <a:cubicBezTo>
                      <a:pt x="114" y="278"/>
                      <a:pt x="354" y="475"/>
                      <a:pt x="430" y="543"/>
                    </a:cubicBezTo>
                    <a:cubicBezTo>
                      <a:pt x="506" y="611"/>
                      <a:pt x="498" y="594"/>
                      <a:pt x="511" y="603"/>
                    </a:cubicBezTo>
                    <a:close/>
                  </a:path>
                </a:pathLst>
              </a:custGeom>
              <a:gradFill rotWithShape="0">
                <a:gsLst>
                  <a:gs pos="0">
                    <a:srgbClr val="ffffff"/>
                  </a:gs>
                  <a:gs pos="100000">
                    <a:srgbClr val="ffff99"/>
                  </a:gs>
                </a:gsLst>
                <a:lin ang="5400000"/>
              </a:gra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flipV="1">
                <a:off x="1147320" y="3060000"/>
                <a:ext cx="873360" cy="29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 flipH="1">
                <a:off x="1714320" y="3058920"/>
                <a:ext cx="306360" cy="79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2173680" y="3147840"/>
                <a:ext cx="338400" cy="148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2175480" y="3147840"/>
                <a:ext cx="127080" cy="448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flipH="1" flipV="1">
                <a:off x="2073600" y="3009960"/>
                <a:ext cx="99720" cy="13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 flipH="1">
                <a:off x="2020320" y="3009960"/>
                <a:ext cx="53280" cy="50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" bIns="3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 flipV="1">
                <a:off x="2073960" y="2863800"/>
                <a:ext cx="3240" cy="146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2075400" y="2862360"/>
                <a:ext cx="6282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H="1" flipV="1">
                <a:off x="2043000" y="2804400"/>
                <a:ext cx="32040" cy="59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 flipV="1">
                <a:off x="2044800" y="2771280"/>
                <a:ext cx="10440" cy="35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520" bIns="-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 flipV="1">
                <a:off x="2058120" y="2559240"/>
                <a:ext cx="314280" cy="210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1394280" y="2684160"/>
                <a:ext cx="654120" cy="122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 flipH="1" flipV="1">
                <a:off x="2048400" y="2742840"/>
                <a:ext cx="7200" cy="25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 flipH="1" flipV="1">
                <a:off x="1620360" y="2257200"/>
                <a:ext cx="425880" cy="48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 flipV="1">
                <a:off x="2048400" y="2394720"/>
                <a:ext cx="37800" cy="34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 flipV="1">
                <a:off x="2089440" y="2336400"/>
                <a:ext cx="84240" cy="61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0" bIns="14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 flipH="1" flipV="1">
                <a:off x="2058840" y="2232360"/>
                <a:ext cx="28800" cy="164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1926000" y="2095200"/>
                <a:ext cx="195480" cy="97920"/>
              </a:xfrm>
              <a:prstGeom prst="rect">
                <a:avLst/>
              </a:prstGeom>
              <a:solidFill>
                <a:srgbClr val="99ffcc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Tc 1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2116800" y="2215800"/>
                <a:ext cx="192960" cy="99000"/>
              </a:xfrm>
              <a:prstGeom prst="rect">
                <a:avLst/>
              </a:prstGeom>
              <a:solidFill>
                <a:srgbClr val="99ffcc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Tc 2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2404080" y="2513160"/>
                <a:ext cx="502920" cy="914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Am GB14138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1008000" y="2573280"/>
                <a:ext cx="498600" cy="914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Am GB18955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1502280" y="2143080"/>
                <a:ext cx="194760" cy="98280"/>
              </a:xfrm>
              <a:prstGeom prst="rect">
                <a:avLst/>
              </a:prstGeom>
              <a:solidFill>
                <a:srgbClr val="99ffcc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Tc 3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741400" y="2810160"/>
                <a:ext cx="198720" cy="91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ff0000"/>
                    </a:solidFill>
                    <a:latin typeface="Arial"/>
                    <a:ea typeface="宋体"/>
                  </a:rPr>
                  <a:t>Ag 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2529720" y="3258720"/>
                <a:ext cx="339840" cy="9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ff0000"/>
                    </a:solidFill>
                    <a:latin typeface="Arial"/>
                    <a:ea typeface="宋体"/>
                  </a:rPr>
                  <a:t>Ag 2a/2b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075400" y="3624120"/>
                <a:ext cx="514440" cy="91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CG1201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1461960" y="3860640"/>
                <a:ext cx="529920" cy="9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CG1511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988920" y="3378240"/>
                <a:ext cx="212760" cy="91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ff0000"/>
                    </a:solidFill>
                    <a:latin typeface="Arial"/>
                    <a:ea typeface="宋体"/>
                  </a:rPr>
                  <a:t>Ag 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543760" y="3911760"/>
                <a:ext cx="266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2599200" y="376236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flipH="1" flipV="1" rot="15530400">
                <a:off x="2032560" y="2376720"/>
                <a:ext cx="42840" cy="4680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 flipH="1">
                <a:off x="2414160" y="3401280"/>
                <a:ext cx="192960" cy="19728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1" name=""/>
            <p:cNvGrpSpPr/>
            <p:nvPr/>
          </p:nvGrpSpPr>
          <p:grpSpPr>
            <a:xfrm>
              <a:off x="1628640" y="4576680"/>
              <a:ext cx="2781360" cy="2677680"/>
              <a:chOff x="1628640" y="4576680"/>
              <a:chExt cx="2781360" cy="2677680"/>
            </a:xfrm>
          </p:grpSpPr>
          <p:sp>
            <p:nvSpPr>
              <p:cNvPr id="82" name=""/>
              <p:cNvSpPr/>
              <p:nvPr/>
            </p:nvSpPr>
            <p:spPr>
              <a:xfrm>
                <a:off x="1628640" y="5911560"/>
                <a:ext cx="885960" cy="409320"/>
              </a:xfrm>
              <a:custGeom>
                <a:avLst/>
                <a:gdLst/>
                <a:ahLst/>
                <a:rect l="l" t="t" r="r" b="b"/>
                <a:pathLst>
                  <a:path w="509" h="200">
                    <a:moveTo>
                      <a:pt x="439" y="191"/>
                    </a:moveTo>
                    <a:cubicBezTo>
                      <a:pt x="509" y="186"/>
                      <a:pt x="482" y="157"/>
                      <a:pt x="479" y="131"/>
                    </a:cubicBezTo>
                    <a:cubicBezTo>
                      <a:pt x="476" y="105"/>
                      <a:pt x="454" y="54"/>
                      <a:pt x="421" y="33"/>
                    </a:cubicBezTo>
                    <a:cubicBezTo>
                      <a:pt x="388" y="12"/>
                      <a:pt x="337" y="0"/>
                      <a:pt x="283" y="4"/>
                    </a:cubicBezTo>
                    <a:cubicBezTo>
                      <a:pt x="229" y="8"/>
                      <a:pt x="137" y="32"/>
                      <a:pt x="99" y="58"/>
                    </a:cubicBezTo>
                    <a:cubicBezTo>
                      <a:pt x="61" y="84"/>
                      <a:pt x="0" y="141"/>
                      <a:pt x="57" y="163"/>
                    </a:cubicBezTo>
                    <a:cubicBezTo>
                      <a:pt x="114" y="184"/>
                      <a:pt x="372" y="200"/>
                      <a:pt x="439" y="191"/>
                    </a:cubicBezTo>
                    <a:close/>
                  </a:path>
                </a:pathLst>
              </a:custGeom>
              <a:gradFill rotWithShape="0">
                <a:gsLst>
                  <a:gs pos="0">
                    <a:srgbClr val="bbe0e3"/>
                  </a:gs>
                  <a:gs pos="100000">
                    <a:srgbClr val="ffffff"/>
                  </a:gs>
                </a:gsLst>
                <a:lin ang="13500000"/>
              </a:gra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2028960" y="5398920"/>
                <a:ext cx="780840" cy="565560"/>
              </a:xfrm>
              <a:custGeom>
                <a:avLst/>
                <a:gdLst/>
                <a:ahLst/>
                <a:rect l="l" t="t" r="r" b="b"/>
                <a:pathLst>
                  <a:path w="430" h="252">
                    <a:moveTo>
                      <a:pt x="425" y="27"/>
                    </a:moveTo>
                    <a:cubicBezTo>
                      <a:pt x="419" y="0"/>
                      <a:pt x="245" y="58"/>
                      <a:pt x="181" y="67"/>
                    </a:cubicBezTo>
                    <a:cubicBezTo>
                      <a:pt x="117" y="76"/>
                      <a:pt x="66" y="62"/>
                      <a:pt x="41" y="79"/>
                    </a:cubicBezTo>
                    <a:cubicBezTo>
                      <a:pt x="16" y="96"/>
                      <a:pt x="0" y="142"/>
                      <a:pt x="29" y="167"/>
                    </a:cubicBezTo>
                    <a:cubicBezTo>
                      <a:pt x="58" y="192"/>
                      <a:pt x="152" y="252"/>
                      <a:pt x="217" y="231"/>
                    </a:cubicBezTo>
                    <a:cubicBezTo>
                      <a:pt x="282" y="210"/>
                      <a:pt x="430" y="52"/>
                      <a:pt x="425" y="27"/>
                    </a:cubicBezTo>
                    <a:close/>
                  </a:path>
                </a:pathLst>
              </a:custGeom>
              <a:gradFill rotWithShape="0">
                <a:gsLst>
                  <a:gs pos="0">
                    <a:srgbClr val="ffff99"/>
                  </a:gs>
                  <a:gs pos="100000">
                    <a:srgbClr val="ffffff"/>
                  </a:gs>
                </a:gsLst>
                <a:lin ang="8100000"/>
              </a:gra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2741400" y="4690440"/>
                <a:ext cx="9000" cy="463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2464200" y="4748040"/>
                <a:ext cx="286200" cy="40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2296440" y="4986000"/>
                <a:ext cx="471960" cy="231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750400" y="5154480"/>
                <a:ext cx="1800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2768760" y="5218200"/>
                <a:ext cx="66600" cy="207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2428560" y="5247720"/>
                <a:ext cx="288720" cy="164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2392200" y="5359320"/>
                <a:ext cx="325080" cy="56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2717280" y="5416200"/>
                <a:ext cx="23760" cy="11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 flipV="1">
                <a:off x="2384640" y="5427360"/>
                <a:ext cx="356400" cy="4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" bIns="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2741400" y="5427720"/>
                <a:ext cx="60120" cy="7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0" bIns="-39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 flipV="1">
                <a:off x="2356560" y="5496840"/>
                <a:ext cx="369000" cy="122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 flipV="1">
                <a:off x="2519280" y="5500440"/>
                <a:ext cx="206280" cy="169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 flipV="1">
                <a:off x="2725920" y="5436720"/>
                <a:ext cx="7560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 flipV="1">
                <a:off x="2801520" y="5426280"/>
                <a:ext cx="33840" cy="8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160" bIns="-38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2835720" y="5426280"/>
                <a:ext cx="9144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2927160" y="5446800"/>
                <a:ext cx="32040" cy="45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" bIns="-1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 flipV="1">
                <a:off x="2927160" y="5408280"/>
                <a:ext cx="28800" cy="37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 flipV="1">
                <a:off x="2955960" y="5378040"/>
                <a:ext cx="8640" cy="30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 flipV="1">
                <a:off x="2964960" y="5285520"/>
                <a:ext cx="75960" cy="92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 flipV="1">
                <a:off x="2964960" y="4734720"/>
                <a:ext cx="58320" cy="64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 flipH="1">
                <a:off x="3037320" y="4843440"/>
                <a:ext cx="216360" cy="445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 flipV="1">
                <a:off x="3034440" y="4910040"/>
                <a:ext cx="516600" cy="38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V="1">
                <a:off x="2954520" y="5202000"/>
                <a:ext cx="676080" cy="206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 flipV="1">
                <a:off x="2959560" y="5491440"/>
                <a:ext cx="731160" cy="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2960280" y="5492160"/>
                <a:ext cx="141120" cy="285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 flipH="1">
                <a:off x="3019320" y="5775120"/>
                <a:ext cx="78120" cy="567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3098160" y="5775120"/>
                <a:ext cx="1081440" cy="29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3019680" y="6339960"/>
                <a:ext cx="112320" cy="136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3130200" y="6477120"/>
                <a:ext cx="11376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3243240" y="6526440"/>
                <a:ext cx="444240" cy="105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 flipH="1">
                <a:off x="3119760" y="6477120"/>
                <a:ext cx="12240" cy="163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240000" y="6524280"/>
                <a:ext cx="330840" cy="430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3119760" y="6640560"/>
                <a:ext cx="123480" cy="509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 flipH="1">
                <a:off x="2870280" y="6638760"/>
                <a:ext cx="249120" cy="485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 flipH="1">
                <a:off x="2711520" y="6343200"/>
                <a:ext cx="307800" cy="85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 flipH="1" flipV="1">
                <a:off x="2663640" y="6415200"/>
                <a:ext cx="47880" cy="12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 flipH="1">
                <a:off x="2235240" y="6415200"/>
                <a:ext cx="428400" cy="39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 flipH="1" flipV="1">
                <a:off x="2345400" y="6201720"/>
                <a:ext cx="317880" cy="212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 flipH="1">
                <a:off x="2648880" y="6427440"/>
                <a:ext cx="6264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 flipH="1">
                <a:off x="2521080" y="6527520"/>
                <a:ext cx="130320" cy="358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 flipH="1">
                <a:off x="2317680" y="6537240"/>
                <a:ext cx="321840" cy="187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2626560" y="4576680"/>
                <a:ext cx="202320" cy="9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ff0000"/>
                    </a:solidFill>
                    <a:latin typeface="Arial"/>
                    <a:ea typeface="宋体"/>
                  </a:rPr>
                  <a:t>Ag 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2341080" y="4631760"/>
                <a:ext cx="197280" cy="99720"/>
              </a:xfrm>
              <a:prstGeom prst="rect">
                <a:avLst/>
              </a:prstGeom>
              <a:solidFill>
                <a:srgbClr val="99ffcc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Tc 3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2036160" y="4878000"/>
                <a:ext cx="482040" cy="9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CG127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2026440" y="5139720"/>
                <a:ext cx="500760" cy="9072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Am GB19380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1915920" y="5303160"/>
                <a:ext cx="477000" cy="87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CG163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2854440" y="4608000"/>
                <a:ext cx="499320" cy="9216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Am GB10972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3202200" y="4716000"/>
                <a:ext cx="204480" cy="90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ff0000"/>
                    </a:solidFill>
                    <a:latin typeface="Arial"/>
                    <a:ea typeface="宋体"/>
                  </a:rPr>
                  <a:t>Ag 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3381480" y="4820760"/>
                <a:ext cx="464760" cy="90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CG582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3656160" y="5125680"/>
                <a:ext cx="194760" cy="99720"/>
              </a:xfrm>
              <a:prstGeom prst="rect">
                <a:avLst/>
              </a:prstGeom>
              <a:solidFill>
                <a:srgbClr val="99ffcc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Tc 1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3723840" y="5428440"/>
                <a:ext cx="477720" cy="93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CG688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3910680" y="6089040"/>
                <a:ext cx="499320" cy="9216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Am GB15788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3338280" y="6978240"/>
                <a:ext cx="501840" cy="9396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Am GB10803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3166560" y="7162200"/>
                <a:ext cx="194760" cy="9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ff0000"/>
                    </a:solidFill>
                    <a:latin typeface="Arial"/>
                    <a:ea typeface="宋体"/>
                  </a:rPr>
                  <a:t>Ag 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3720600" y="6584400"/>
                <a:ext cx="195480" cy="100440"/>
              </a:xfrm>
              <a:prstGeom prst="rect">
                <a:avLst/>
              </a:prstGeom>
              <a:solidFill>
                <a:srgbClr val="99ffcc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Tc 5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2626560" y="7142400"/>
                <a:ext cx="473760" cy="91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CG308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2408040" y="6905520"/>
                <a:ext cx="196200" cy="98280"/>
              </a:xfrm>
              <a:prstGeom prst="rect">
                <a:avLst/>
              </a:prstGeom>
              <a:solidFill>
                <a:srgbClr val="99ffcc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Tc 4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1968840" y="6742080"/>
                <a:ext cx="501120" cy="9288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Am GB10498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2057040" y="6416640"/>
                <a:ext cx="217800" cy="93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ff0000"/>
                    </a:solidFill>
                    <a:latin typeface="Arial"/>
                    <a:ea typeface="宋体"/>
                  </a:rPr>
                  <a:t>Ag 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1809360" y="6164280"/>
                <a:ext cx="500760" cy="9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CG1289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1868040" y="6066720"/>
                <a:ext cx="530640" cy="90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CG1176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2136240" y="5577840"/>
                <a:ext cx="195480" cy="100440"/>
              </a:xfrm>
              <a:prstGeom prst="rect">
                <a:avLst/>
              </a:prstGeom>
              <a:solidFill>
                <a:srgbClr val="99ffcc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Tc 2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2366640" y="5684400"/>
                <a:ext cx="195480" cy="99720"/>
              </a:xfrm>
              <a:prstGeom prst="rect">
                <a:avLst/>
              </a:prstGeom>
              <a:solidFill>
                <a:srgbClr val="99ffcc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Tc 6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2197440" y="5419440"/>
                <a:ext cx="194760" cy="91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ff0000"/>
                    </a:solidFill>
                    <a:latin typeface="Arial"/>
                    <a:ea typeface="宋体"/>
                  </a:rPr>
                  <a:t>Ag 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 flipH="1">
                <a:off x="2321280" y="6205680"/>
                <a:ext cx="24480" cy="1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360" bIns="-36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2343600" y="6197040"/>
                <a:ext cx="3960" cy="5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 flipH="1" flipV="1" rot="8628000">
                <a:off x="3041640" y="5287320"/>
                <a:ext cx="42840" cy="4680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3936960" y="7202880"/>
                <a:ext cx="338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4043520" y="70531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 flipH="1" flipV="1" rot="2967600">
                <a:off x="3100320" y="5727960"/>
                <a:ext cx="42480" cy="4788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 rot="15116400">
                <a:off x="2754360" y="5110920"/>
                <a:ext cx="42840" cy="4680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 flipH="1" flipV="1" rot="6654000">
                <a:off x="2656080" y="6524280"/>
                <a:ext cx="42840" cy="4752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 rot="310200">
                <a:off x="2321640" y="6210360"/>
                <a:ext cx="42840" cy="4680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 rot="15295800">
                <a:off x="2774160" y="5182920"/>
                <a:ext cx="42840" cy="4752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 rot="11990400">
                <a:off x="2331000" y="6145920"/>
                <a:ext cx="42840" cy="4716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 flipH="1" flipV="1" rot="4864800">
                <a:off x="3030120" y="6312600"/>
                <a:ext cx="43560" cy="4716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 rot="11170200">
                <a:off x="2689920" y="6375240"/>
                <a:ext cx="43560" cy="4680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 flipH="1" flipV="1" rot="5400000">
                <a:off x="3131280" y="6613920"/>
                <a:ext cx="42840" cy="4716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 rot="13414200">
                <a:off x="3131640" y="6432120"/>
                <a:ext cx="42840" cy="4716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 rot="11990400">
                <a:off x="3233160" y="6469560"/>
                <a:ext cx="42840" cy="4788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 rot="19060200">
                <a:off x="2712600" y="5501520"/>
                <a:ext cx="43560" cy="4788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1931400" y="5972040"/>
                <a:ext cx="468000" cy="9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Prx254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 flipV="1">
                <a:off x="2236320" y="4764600"/>
                <a:ext cx="108000" cy="9900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 flipV="1">
                <a:off x="2560680" y="4638600"/>
                <a:ext cx="56880" cy="1224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3379680" y="4777920"/>
                <a:ext cx="102960" cy="3384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 flipH="1">
                <a:off x="3646440" y="6747120"/>
                <a:ext cx="123840" cy="16668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 flipH="1">
                <a:off x="3341160" y="7094520"/>
                <a:ext cx="137880" cy="7596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3070080" y="7190280"/>
                <a:ext cx="85680" cy="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2189160" y="6542280"/>
                <a:ext cx="71640" cy="15264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2351160" y="6841800"/>
                <a:ext cx="56880" cy="5292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4" name=""/>
            <p:cNvGrpSpPr/>
            <p:nvPr/>
          </p:nvGrpSpPr>
          <p:grpSpPr>
            <a:xfrm>
              <a:off x="3341520" y="1763640"/>
              <a:ext cx="2513160" cy="2528640"/>
              <a:chOff x="3341520" y="1763640"/>
              <a:chExt cx="2513160" cy="2528640"/>
            </a:xfrm>
          </p:grpSpPr>
          <p:sp>
            <p:nvSpPr>
              <p:cNvPr id="175" name=""/>
              <p:cNvSpPr/>
              <p:nvPr/>
            </p:nvSpPr>
            <p:spPr>
              <a:xfrm flipH="1" flipV="1">
                <a:off x="3626280" y="2725200"/>
                <a:ext cx="647280" cy="120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 flipV="1">
                <a:off x="4550040" y="2042280"/>
                <a:ext cx="366480" cy="424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 flipV="1">
                <a:off x="4548600" y="2257200"/>
                <a:ext cx="605880" cy="209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 flipH="1">
                <a:off x="4500360" y="2466720"/>
                <a:ext cx="47880" cy="30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 flipV="1">
                <a:off x="4500720" y="1896840"/>
                <a:ext cx="174240" cy="600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 flipH="1">
                <a:off x="4393800" y="2091960"/>
                <a:ext cx="32040" cy="255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4290840" y="2077920"/>
                <a:ext cx="102960" cy="27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4119120" y="2102040"/>
                <a:ext cx="276480" cy="321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4394160" y="2347920"/>
                <a:ext cx="1440" cy="78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040" bIns="32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3994560" y="2236320"/>
                <a:ext cx="410400" cy="212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4394160" y="2420640"/>
                <a:ext cx="10800" cy="30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4404960" y="2450880"/>
                <a:ext cx="50760" cy="87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 flipV="1">
                <a:off x="4456080" y="2499840"/>
                <a:ext cx="42840" cy="38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920" bIns="-7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 flipH="1">
                <a:off x="4445640" y="2538720"/>
                <a:ext cx="9720" cy="37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4448520" y="2576520"/>
                <a:ext cx="25560" cy="30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4474080" y="2609640"/>
                <a:ext cx="24480" cy="69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 flipH="1">
                <a:off x="4462560" y="2679840"/>
                <a:ext cx="34560" cy="69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 flipH="1">
                <a:off x="4282920" y="2750760"/>
                <a:ext cx="177480" cy="9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3871440" y="2432160"/>
                <a:ext cx="576720" cy="14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 flipH="1">
                <a:off x="3638160" y="2841480"/>
                <a:ext cx="644760" cy="302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 flipV="1">
                <a:off x="3697200" y="3699360"/>
                <a:ext cx="431640" cy="215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 flipH="1" flipV="1">
                <a:off x="4129200" y="3699360"/>
                <a:ext cx="75600" cy="479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 flipV="1">
                <a:off x="4129200" y="2848680"/>
                <a:ext cx="335160" cy="849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 flipH="1" flipV="1">
                <a:off x="4462560" y="2749320"/>
                <a:ext cx="1440" cy="99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4464360" y="2849040"/>
                <a:ext cx="182520" cy="424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4646880" y="3273120"/>
                <a:ext cx="201240" cy="517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4646880" y="3271320"/>
                <a:ext cx="540000" cy="206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 flipH="1" flipV="1">
                <a:off x="4497120" y="2679480"/>
                <a:ext cx="743040" cy="292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 flipV="1">
                <a:off x="4474080" y="2604240"/>
                <a:ext cx="850320" cy="2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280" bIns="-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3641760" y="2360160"/>
                <a:ext cx="298080" cy="90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ff0000"/>
                    </a:solidFill>
                    <a:latin typeface="Arial"/>
                    <a:ea typeface="宋体"/>
                  </a:rPr>
                  <a:t>Ag 3b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3620160" y="2122560"/>
                <a:ext cx="511560" cy="9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CG1179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3976200" y="1974960"/>
                <a:ext cx="237600" cy="89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ff0000"/>
                    </a:solidFill>
                    <a:latin typeface="Arial"/>
                    <a:ea typeface="宋体"/>
                  </a:rPr>
                  <a:t>Ag 3a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4033080" y="1822680"/>
                <a:ext cx="516960" cy="9576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Am GB10133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5176080" y="2198520"/>
                <a:ext cx="214560" cy="90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ff0000"/>
                    </a:solidFill>
                    <a:latin typeface="Arial"/>
                    <a:ea typeface="宋体"/>
                  </a:rPr>
                  <a:t>Ag 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4768920" y="1943280"/>
                <a:ext cx="459000" cy="91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CG9027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4592160" y="1763640"/>
                <a:ext cx="195480" cy="97920"/>
              </a:xfrm>
              <a:prstGeom prst="rect">
                <a:avLst/>
              </a:prstGeom>
              <a:solidFill>
                <a:srgbClr val="99ffcc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Tc 2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4347000" y="1968120"/>
                <a:ext cx="194760" cy="96480"/>
              </a:xfrm>
              <a:prstGeom prst="rect">
                <a:avLst/>
              </a:prstGeom>
              <a:solidFill>
                <a:srgbClr val="99ffcc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Tc 3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5345280" y="2544120"/>
                <a:ext cx="509400" cy="9072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Am GB14210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5259600" y="2939760"/>
                <a:ext cx="195480" cy="99000"/>
              </a:xfrm>
              <a:prstGeom prst="rect">
                <a:avLst/>
              </a:prstGeom>
              <a:solidFill>
                <a:srgbClr val="99ffcc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Tc 4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5207400" y="3423600"/>
                <a:ext cx="514080" cy="1004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Am GB14567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4779720" y="3823920"/>
                <a:ext cx="195480" cy="99000"/>
              </a:xfrm>
              <a:prstGeom prst="rect">
                <a:avLst/>
              </a:prstGeom>
              <a:solidFill>
                <a:srgbClr val="99ffcc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Tc 1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3568320" y="3917880"/>
                <a:ext cx="203760" cy="9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ff0000"/>
                    </a:solidFill>
                    <a:latin typeface="Arial"/>
                    <a:ea typeface="宋体"/>
                  </a:rPr>
                  <a:t>Ag 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3934080" y="4191120"/>
                <a:ext cx="479520" cy="101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CG890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3341520" y="3154320"/>
                <a:ext cx="467280" cy="91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66"/>
                    </a:solidFill>
                    <a:latin typeface="Arial"/>
                    <a:ea typeface="宋体"/>
                  </a:rPr>
                  <a:t>Dm CG594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3427200" y="2623680"/>
                <a:ext cx="207000" cy="88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ff0000"/>
                    </a:solidFill>
                    <a:latin typeface="Arial"/>
                    <a:ea typeface="宋体"/>
                  </a:rPr>
                  <a:t>Ag 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5264280" y="3992040"/>
                <a:ext cx="142560" cy="122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 rot="16041600">
                <a:off x="4404240" y="2307240"/>
                <a:ext cx="42840" cy="4716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 flipH="1" flipV="1" rot="13490400">
                <a:off x="4353480" y="2446920"/>
                <a:ext cx="42840" cy="4752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 rot="10800000">
                <a:off x="4249080" y="2782800"/>
                <a:ext cx="42840" cy="4680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 rot="13261800">
                <a:off x="4644720" y="3222360"/>
                <a:ext cx="42840" cy="4716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 rot="16609200">
                <a:off x="4145760" y="3681720"/>
                <a:ext cx="42840" cy="4680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5217480" y="4145040"/>
                <a:ext cx="2530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3764160" y="4006800"/>
                <a:ext cx="247320" cy="15192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 flipV="1">
                <a:off x="5046480" y="3625560"/>
                <a:ext cx="216000" cy="15912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3554280" y="2806920"/>
                <a:ext cx="0" cy="26640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 flipV="1">
                <a:off x="4094280" y="1924200"/>
                <a:ext cx="126360" cy="3780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 flipV="1">
                <a:off x="3909600" y="2070000"/>
                <a:ext cx="44280" cy="3780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4309920" y="1924560"/>
                <a:ext cx="108000" cy="18720"/>
              </a:xfrm>
              <a:prstGeom prst="line">
                <a:avLst/>
              </a:prstGeom>
              <a:ln w="19080">
                <a:solidFill>
                  <a:srgbClr val="00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 flipH="1" flipV="1" rot="6058800">
                <a:off x="4473000" y="2734560"/>
                <a:ext cx="42840" cy="4716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 flipH="1" flipV="1" rot="16044600">
                <a:off x="4447440" y="2654280"/>
                <a:ext cx="42840" cy="4716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 flipH="1" flipV="1" rot="5026200">
                <a:off x="4477680" y="2820600"/>
                <a:ext cx="42840" cy="47880"/>
              </a:xfrm>
              <a:prstGeom prst="triangle">
                <a:avLst>
                  <a:gd name="adj" fmla="val 50000"/>
                </a:avLst>
              </a:prstGeom>
              <a:solidFill>
                <a:srgbClr val="ff0066"/>
              </a:solidFill>
              <a:ln w="3240">
                <a:solidFill>
                  <a:srgbClr val="ff00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03T20:47:33Z</dcterms:created>
  <dc:creator>haobo</dc:creator>
  <dc:description/>
  <dc:language>en-US</dc:language>
  <cp:lastModifiedBy>Haobo Jiang</cp:lastModifiedBy>
  <dcterms:modified xsi:type="dcterms:W3CDTF">2007-08-08T18:33:42Z</dcterms:modified>
  <cp:revision>103</cp:revision>
  <dc:subject/>
  <dc:title>Slide 1</dc:title>
</cp:coreProperties>
</file>